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20" d="100"/>
          <a:sy n="120" d="100"/>
        </p:scale>
        <p:origin x="174" y="-10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DAF94-D2E9-487D-9673-531A98A3C9C4}" type="datetimeFigureOut">
              <a:rPr lang="en-AU" smtClean="0"/>
              <a:t>15/10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FF59D-EBCF-4454-B50E-727420A578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480388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DAF94-D2E9-487D-9673-531A98A3C9C4}" type="datetimeFigureOut">
              <a:rPr lang="en-AU" smtClean="0"/>
              <a:t>15/10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FF59D-EBCF-4454-B50E-727420A578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793264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DAF94-D2E9-487D-9673-531A98A3C9C4}" type="datetimeFigureOut">
              <a:rPr lang="en-AU" smtClean="0"/>
              <a:t>15/10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FF59D-EBCF-4454-B50E-727420A578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43273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DAF94-D2E9-487D-9673-531A98A3C9C4}" type="datetimeFigureOut">
              <a:rPr lang="en-AU" smtClean="0"/>
              <a:t>15/10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FF59D-EBCF-4454-B50E-727420A578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892083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DAF94-D2E9-487D-9673-531A98A3C9C4}" type="datetimeFigureOut">
              <a:rPr lang="en-AU" smtClean="0"/>
              <a:t>15/10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FF59D-EBCF-4454-B50E-727420A578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771481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DAF94-D2E9-487D-9673-531A98A3C9C4}" type="datetimeFigureOut">
              <a:rPr lang="en-AU" smtClean="0"/>
              <a:t>15/10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FF59D-EBCF-4454-B50E-727420A578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26346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DAF94-D2E9-487D-9673-531A98A3C9C4}" type="datetimeFigureOut">
              <a:rPr lang="en-AU" smtClean="0"/>
              <a:t>15/10/2021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FF59D-EBCF-4454-B50E-727420A578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30326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DAF94-D2E9-487D-9673-531A98A3C9C4}" type="datetimeFigureOut">
              <a:rPr lang="en-AU" smtClean="0"/>
              <a:t>15/10/2021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FF59D-EBCF-4454-B50E-727420A578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775849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DAF94-D2E9-487D-9673-531A98A3C9C4}" type="datetimeFigureOut">
              <a:rPr lang="en-AU" smtClean="0"/>
              <a:t>15/10/2021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FF59D-EBCF-4454-B50E-727420A578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08922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DAF94-D2E9-487D-9673-531A98A3C9C4}" type="datetimeFigureOut">
              <a:rPr lang="en-AU" smtClean="0"/>
              <a:t>15/10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FF59D-EBCF-4454-B50E-727420A578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21320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DAF94-D2E9-487D-9673-531A98A3C9C4}" type="datetimeFigureOut">
              <a:rPr lang="en-AU" smtClean="0"/>
              <a:t>15/10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4FF59D-EBCF-4454-B50E-727420A578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22156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BDAF94-D2E9-487D-9673-531A98A3C9C4}" type="datetimeFigureOut">
              <a:rPr lang="en-AU" smtClean="0"/>
              <a:t>15/10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4FF59D-EBCF-4454-B50E-727420A578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72002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 rot="16200000">
            <a:off x="1909284" y="1259430"/>
            <a:ext cx="14547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/>
              <a:t>Event Count</a:t>
            </a:r>
            <a:endParaRPr lang="en-AU" sz="12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3483035" y="639584"/>
            <a:ext cx="5902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 smtClean="0"/>
              <a:t>1 hr</a:t>
            </a:r>
            <a:endParaRPr lang="en-AU" sz="1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4781125" y="639584"/>
            <a:ext cx="5902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/>
              <a:t>6</a:t>
            </a:r>
            <a:r>
              <a:rPr lang="en-AU" sz="1400" b="1" dirty="0" smtClean="0"/>
              <a:t> hr</a:t>
            </a:r>
            <a:endParaRPr lang="en-AU" sz="1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6118168" y="659575"/>
            <a:ext cx="8562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 smtClean="0"/>
              <a:t>24 hr</a:t>
            </a:r>
            <a:endParaRPr lang="en-AU" sz="14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7376160" y="653429"/>
            <a:ext cx="8562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 smtClean="0"/>
              <a:t>48 hr</a:t>
            </a:r>
            <a:endParaRPr lang="en-AU" sz="14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8687455" y="662751"/>
            <a:ext cx="85621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500" b="1" dirty="0" smtClean="0"/>
              <a:t>72 hr</a:t>
            </a:r>
            <a:endParaRPr lang="en-AU" sz="1500" b="1" dirty="0"/>
          </a:p>
        </p:txBody>
      </p:sp>
      <p:grpSp>
        <p:nvGrpSpPr>
          <p:cNvPr id="2" name="Group 1"/>
          <p:cNvGrpSpPr/>
          <p:nvPr/>
        </p:nvGrpSpPr>
        <p:grpSpPr>
          <a:xfrm>
            <a:off x="1690233" y="251144"/>
            <a:ext cx="8021563" cy="6542258"/>
            <a:chOff x="1690233" y="251144"/>
            <a:chExt cx="8021563" cy="6542258"/>
          </a:xfrm>
        </p:grpSpPr>
        <p:grpSp>
          <p:nvGrpSpPr>
            <p:cNvPr id="3" name="Group 2"/>
            <p:cNvGrpSpPr/>
            <p:nvPr/>
          </p:nvGrpSpPr>
          <p:grpSpPr>
            <a:xfrm>
              <a:off x="1690233" y="896107"/>
              <a:ext cx="8021563" cy="5897295"/>
              <a:chOff x="1690233" y="598517"/>
              <a:chExt cx="8021563" cy="5897295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775148" y="598517"/>
                <a:ext cx="6842680" cy="5367791"/>
              </a:xfrm>
              <a:prstGeom prst="rect">
                <a:avLst/>
              </a:prstGeom>
            </p:spPr>
          </p:pic>
          <p:cxnSp>
            <p:nvCxnSpPr>
              <p:cNvPr id="6" name="Straight Connector 5"/>
              <p:cNvCxnSpPr/>
              <p:nvPr/>
            </p:nvCxnSpPr>
            <p:spPr>
              <a:xfrm flipV="1">
                <a:off x="3034147" y="6134794"/>
                <a:ext cx="6591992" cy="16625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" name="TextBox 6"/>
              <p:cNvSpPr txBox="1"/>
              <p:nvPr/>
            </p:nvSpPr>
            <p:spPr>
              <a:xfrm>
                <a:off x="5461463" y="6126480"/>
                <a:ext cx="216962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dirty="0" smtClean="0"/>
                  <a:t>DNA Content (DAPI)</a:t>
                </a:r>
                <a:endParaRPr lang="en-AU" dirty="0"/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 rot="16200000">
                <a:off x="1909285" y="4862945"/>
                <a:ext cx="145472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200" b="1" dirty="0" smtClean="0"/>
                  <a:t>Event Count</a:t>
                </a:r>
                <a:endParaRPr lang="en-AU" sz="1200" b="1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 rot="16200000">
                <a:off x="1909285" y="3510741"/>
                <a:ext cx="145472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200" b="1" dirty="0" smtClean="0"/>
                  <a:t>Event Count</a:t>
                </a:r>
                <a:endParaRPr lang="en-AU" sz="1200" b="1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 rot="16200000">
                <a:off x="1909285" y="2246538"/>
                <a:ext cx="145472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200" b="1" dirty="0" smtClean="0"/>
                  <a:t>Event Count</a:t>
                </a:r>
                <a:endParaRPr lang="en-AU" sz="1200" b="1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 rot="16200000">
                <a:off x="389024" y="2296633"/>
                <a:ext cx="297175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b="1" dirty="0" smtClean="0"/>
                  <a:t>Radiation Dose </a:t>
                </a:r>
                <a:endParaRPr lang="en-AU" b="1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 rot="16200000">
                <a:off x="1973106" y="1045867"/>
                <a:ext cx="7398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400" b="1" dirty="0" smtClean="0"/>
                  <a:t>0 </a:t>
                </a:r>
                <a:r>
                  <a:rPr lang="en-AU" sz="1400" b="1" dirty="0" err="1" smtClean="0"/>
                  <a:t>Gy</a:t>
                </a:r>
                <a:endParaRPr lang="en-AU" sz="1400" b="1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 rot="16200000">
                <a:off x="1989732" y="2327411"/>
                <a:ext cx="7398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400" b="1" dirty="0"/>
                  <a:t>2</a:t>
                </a:r>
                <a:r>
                  <a:rPr lang="en-AU" sz="1400" b="1" dirty="0" smtClean="0"/>
                  <a:t> </a:t>
                </a:r>
                <a:r>
                  <a:rPr lang="en-AU" sz="1400" b="1" dirty="0" err="1" smtClean="0"/>
                  <a:t>Gy</a:t>
                </a:r>
                <a:endParaRPr lang="en-AU" sz="1400" b="1" dirty="0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 rot="16200000">
                <a:off x="1999556" y="3601633"/>
                <a:ext cx="7398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400" b="1" dirty="0" smtClean="0"/>
                  <a:t>8 </a:t>
                </a:r>
                <a:r>
                  <a:rPr lang="en-AU" sz="1400" b="1" dirty="0" err="1" smtClean="0"/>
                  <a:t>Gy</a:t>
                </a:r>
                <a:endParaRPr lang="en-AU" sz="1400" b="1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 rot="16200000">
                <a:off x="2022983" y="4935380"/>
                <a:ext cx="7398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400" b="1" dirty="0" smtClean="0"/>
                  <a:t>16 </a:t>
                </a:r>
                <a:r>
                  <a:rPr lang="en-AU" sz="1400" b="1" dirty="0" err="1" smtClean="0"/>
                  <a:t>Gy</a:t>
                </a:r>
                <a:endParaRPr lang="en-AU" sz="1400" b="1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3516287" y="761785"/>
                <a:ext cx="77308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b="1" dirty="0" smtClean="0"/>
                  <a:t>% G0G1= 38.0</a:t>
                </a:r>
              </a:p>
              <a:p>
                <a:r>
                  <a:rPr lang="en-AU" sz="800" b="1" dirty="0" smtClean="0"/>
                  <a:t>% G2M= 14.1</a:t>
                </a:r>
                <a:endParaRPr lang="en-AU" sz="800" b="1" dirty="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4874032" y="761785"/>
                <a:ext cx="77308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b="1" dirty="0" smtClean="0"/>
                  <a:t>% G0G1= 29.5</a:t>
                </a:r>
              </a:p>
              <a:p>
                <a:r>
                  <a:rPr lang="en-AU" sz="800" b="1" dirty="0" smtClean="0"/>
                  <a:t>% G2M= 7.38</a:t>
                </a:r>
                <a:endParaRPr lang="en-AU" sz="800" b="1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6196488" y="770170"/>
                <a:ext cx="77308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b="1" dirty="0" smtClean="0"/>
                  <a:t>% G0G1= 30.1</a:t>
                </a:r>
              </a:p>
              <a:p>
                <a:r>
                  <a:rPr lang="en-AU" sz="800" b="1" dirty="0" smtClean="0"/>
                  <a:t>% G2M= 7.89</a:t>
                </a:r>
                <a:endParaRPr lang="en-AU" sz="800" b="1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7520616" y="770207"/>
                <a:ext cx="77308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b="1" dirty="0" smtClean="0"/>
                  <a:t>% G0G1= 36.5</a:t>
                </a:r>
              </a:p>
              <a:p>
                <a:r>
                  <a:rPr lang="en-AU" sz="800" b="1" dirty="0" smtClean="0"/>
                  <a:t>% G2M= 6.01</a:t>
                </a:r>
                <a:endParaRPr lang="en-AU" sz="800" b="1" dirty="0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8849897" y="770170"/>
                <a:ext cx="77308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b="1" dirty="0" smtClean="0"/>
                  <a:t>% G0G1= 30.6</a:t>
                </a:r>
              </a:p>
              <a:p>
                <a:r>
                  <a:rPr lang="en-AU" sz="800" b="1" dirty="0" smtClean="0"/>
                  <a:t>% G2M= 8.57</a:t>
                </a:r>
                <a:endParaRPr lang="en-AU" sz="800" b="1" dirty="0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3526352" y="2044716"/>
                <a:ext cx="77308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b="1" dirty="0" smtClean="0"/>
                  <a:t>% G0G1= 36.8</a:t>
                </a:r>
              </a:p>
              <a:p>
                <a:r>
                  <a:rPr lang="en-AU" sz="800" b="1" dirty="0" smtClean="0"/>
                  <a:t>% G2M= 12.2</a:t>
                </a:r>
                <a:endParaRPr lang="en-AU" sz="800" b="1" dirty="0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4884097" y="2044716"/>
                <a:ext cx="77308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b="1" dirty="0" smtClean="0"/>
                  <a:t>% G0G1= 34.9</a:t>
                </a:r>
              </a:p>
              <a:p>
                <a:r>
                  <a:rPr lang="en-AU" sz="800" b="1" dirty="0" smtClean="0"/>
                  <a:t>% G2M= 19.4</a:t>
                </a:r>
                <a:endParaRPr lang="en-AU" sz="800" b="1" dirty="0"/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6206553" y="2053101"/>
                <a:ext cx="77308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b="1" dirty="0" smtClean="0"/>
                  <a:t>% G0G1= 34.8</a:t>
                </a:r>
              </a:p>
              <a:p>
                <a:r>
                  <a:rPr lang="en-AU" sz="800" b="1" dirty="0" smtClean="0"/>
                  <a:t>% G2M= 12.4</a:t>
                </a:r>
                <a:endParaRPr lang="en-AU" sz="800" b="1" dirty="0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7530681" y="2053138"/>
                <a:ext cx="77308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b="1" dirty="0" smtClean="0"/>
                  <a:t>% G0G1= 39.1</a:t>
                </a:r>
              </a:p>
              <a:p>
                <a:r>
                  <a:rPr lang="en-AU" sz="800" b="1" dirty="0" smtClean="0"/>
                  <a:t>% G2M= 6.82</a:t>
                </a:r>
                <a:endParaRPr lang="en-AU" sz="800" b="1" dirty="0"/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8859962" y="2053101"/>
                <a:ext cx="77308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b="1" dirty="0" smtClean="0"/>
                  <a:t>% G0G1= 36.2</a:t>
                </a:r>
              </a:p>
              <a:p>
                <a:r>
                  <a:rPr lang="en-AU" sz="800" b="1" dirty="0" smtClean="0"/>
                  <a:t>% G2M= 5.69</a:t>
                </a:r>
                <a:endParaRPr lang="en-AU" sz="800" b="1" dirty="0"/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3505347" y="3335654"/>
                <a:ext cx="77308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b="1" dirty="0" smtClean="0"/>
                  <a:t>% G0G1= 38.4</a:t>
                </a:r>
              </a:p>
              <a:p>
                <a:r>
                  <a:rPr lang="en-AU" sz="800" b="1" dirty="0" smtClean="0"/>
                  <a:t>% G2M= 10.5</a:t>
                </a:r>
                <a:endParaRPr lang="en-AU" sz="800" b="1" dirty="0"/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4863092" y="3335654"/>
                <a:ext cx="77308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b="1" dirty="0" smtClean="0"/>
                  <a:t>% G0G1= 36.1</a:t>
                </a:r>
              </a:p>
              <a:p>
                <a:r>
                  <a:rPr lang="en-AU" sz="800" b="1" dirty="0" smtClean="0"/>
                  <a:t>% G2M= 15.1</a:t>
                </a:r>
                <a:endParaRPr lang="en-AU" sz="800" b="1" dirty="0"/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6260365" y="3344039"/>
                <a:ext cx="77308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b="1" dirty="0" smtClean="0"/>
                  <a:t>% G0G1= 5.84</a:t>
                </a:r>
              </a:p>
              <a:p>
                <a:r>
                  <a:rPr lang="en-AU" sz="800" b="1" dirty="0" smtClean="0"/>
                  <a:t>% G2M= 47.6</a:t>
                </a:r>
                <a:endParaRPr lang="en-AU" sz="800" b="1" dirty="0"/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7576180" y="3344076"/>
                <a:ext cx="77308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b="1" dirty="0" smtClean="0"/>
                  <a:t>% G0G1= 29.2</a:t>
                </a:r>
              </a:p>
              <a:p>
                <a:r>
                  <a:rPr lang="en-AU" sz="800" b="1" dirty="0" smtClean="0"/>
                  <a:t>% G2M= 10.4</a:t>
                </a:r>
                <a:endParaRPr lang="en-AU" sz="800" b="1" dirty="0"/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8938713" y="3344039"/>
                <a:ext cx="77308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b="1" dirty="0" smtClean="0"/>
                  <a:t>% G0G1= 26.5</a:t>
                </a:r>
              </a:p>
              <a:p>
                <a:r>
                  <a:rPr lang="en-AU" sz="800" b="1" dirty="0" smtClean="0"/>
                  <a:t>% G2M= 6.94</a:t>
                </a:r>
                <a:endParaRPr lang="en-AU" sz="800" b="1" dirty="0"/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3526352" y="4632026"/>
                <a:ext cx="77308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b="1" dirty="0" smtClean="0"/>
                  <a:t>% G0G1= 40.</a:t>
                </a:r>
                <a:r>
                  <a:rPr lang="en-AU" sz="800" b="1" dirty="0"/>
                  <a:t>1</a:t>
                </a:r>
                <a:endParaRPr lang="en-AU" sz="800" b="1" dirty="0" smtClean="0"/>
              </a:p>
              <a:p>
                <a:r>
                  <a:rPr lang="en-AU" sz="800" b="1" dirty="0" smtClean="0"/>
                  <a:t>% G2M= 10.4</a:t>
                </a:r>
                <a:endParaRPr lang="en-AU" sz="800" b="1" dirty="0"/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4884097" y="4632026"/>
                <a:ext cx="77308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b="1" dirty="0" smtClean="0"/>
                  <a:t>% G0G1= 37.2</a:t>
                </a:r>
              </a:p>
              <a:p>
                <a:r>
                  <a:rPr lang="en-AU" sz="800" b="1" dirty="0" smtClean="0"/>
                  <a:t>% G2M= 12.4</a:t>
                </a:r>
                <a:endParaRPr lang="en-AU" sz="800" b="1" dirty="0"/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6206553" y="4640411"/>
                <a:ext cx="77308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b="1" dirty="0" smtClean="0"/>
                  <a:t>% G0G1= 2.28</a:t>
                </a:r>
              </a:p>
              <a:p>
                <a:r>
                  <a:rPr lang="en-AU" sz="800" b="1" dirty="0" smtClean="0"/>
                  <a:t>% G2M= 49.0</a:t>
                </a:r>
                <a:endParaRPr lang="en-AU" sz="800" b="1" dirty="0"/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7572246" y="4640448"/>
                <a:ext cx="77308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b="1" dirty="0" smtClean="0"/>
                  <a:t>% G0G1= 0.39</a:t>
                </a:r>
              </a:p>
              <a:p>
                <a:r>
                  <a:rPr lang="en-AU" sz="800" b="1" dirty="0" smtClean="0"/>
                  <a:t>% G2M= 43.9</a:t>
                </a:r>
                <a:endParaRPr lang="en-AU" sz="800" b="1" dirty="0"/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8859962" y="4640411"/>
                <a:ext cx="77308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800" b="1" dirty="0" smtClean="0"/>
                  <a:t>% G0G1= 2.23</a:t>
                </a:r>
              </a:p>
              <a:p>
                <a:r>
                  <a:rPr lang="en-AU" sz="800" b="1" dirty="0" smtClean="0"/>
                  <a:t>% G2M= 25.3</a:t>
                </a:r>
                <a:endParaRPr lang="en-AU" sz="800" b="1" dirty="0"/>
              </a:p>
            </p:txBody>
          </p:sp>
        </p:grpSp>
        <p:sp>
          <p:nvSpPr>
            <p:cNvPr id="40" name="TextBox 39"/>
            <p:cNvSpPr txBox="1"/>
            <p:nvPr/>
          </p:nvSpPr>
          <p:spPr>
            <a:xfrm>
              <a:off x="4849899" y="251144"/>
              <a:ext cx="289268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b="1" dirty="0" smtClean="0"/>
                <a:t>Time Post Radiation</a:t>
              </a:r>
              <a:endParaRPr lang="en-AU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1046712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2299238" y="1992206"/>
            <a:ext cx="8183112" cy="23083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2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1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2: Flow cytometry data from the AB1 cell line shows photon radiation arrests cell cycle at the G2/M phase after exposure to high dose photon radiation of up to 8 </a:t>
            </a:r>
            <a:r>
              <a:rPr kumimoji="0" lang="en-AU" altLang="en-US" sz="1200" b="1" i="0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y</a:t>
            </a:r>
            <a:r>
              <a:rPr kumimoji="0" lang="en-AU" altLang="en-US" sz="1200" b="1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kumimoji="0" lang="en-AU" altLang="en-US" sz="120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</a:t>
            </a:r>
            <a:r>
              <a:rPr kumimoji="0" lang="en-AU" altLang="en-US" sz="1200" i="0" strike="noStrike" cap="none" normalizeH="0" baseline="0" dirty="0" smtClean="0">
                <a:ln>
                  <a:noFill/>
                </a:ln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r>
              <a:rPr kumimoji="0" lang="en-AU" altLang="en-US" sz="120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0/G1 (purple) and G2/M populations (green) remain unchanged, regardless of time, in untreated and 2 </a:t>
            </a:r>
            <a:r>
              <a:rPr kumimoji="0" lang="en-AU" altLang="en-US" sz="1200" i="0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y</a:t>
            </a:r>
            <a:r>
              <a:rPr kumimoji="0" lang="en-AU" altLang="en-US" sz="120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reatment cells. Greater reduction of G0/G1 and increased G2/M population after AB1 cells were treated with 8</a:t>
            </a:r>
            <a:r>
              <a:rPr kumimoji="0" lang="en-AU" altLang="en-US" sz="1200" i="0" strike="noStrike" cap="none" normalizeH="0" baseline="0" dirty="0" smtClean="0">
                <a:ln>
                  <a:noFill/>
                </a:ln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r>
              <a:rPr kumimoji="0" lang="en-AU" altLang="en-US" sz="1200" i="0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y</a:t>
            </a:r>
            <a:r>
              <a:rPr kumimoji="0" lang="en-AU" altLang="en-US" sz="120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t 24 hours, but cell cycle returns to normal level at 48 hours</a:t>
            </a:r>
            <a:r>
              <a:rPr kumimoji="0" lang="en-AU" altLang="en-US" sz="1200" b="1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kumimoji="0" lang="en-AU" altLang="en-US" sz="120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 comprehensive cell cycle arrest at G2/M after AB1 cells are treated with 16 </a:t>
            </a:r>
            <a:r>
              <a:rPr kumimoji="0" lang="en-AU" altLang="en-US" sz="1200" i="0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y</a:t>
            </a:r>
            <a:r>
              <a:rPr kumimoji="0" lang="en-AU" altLang="en-US" sz="1200" i="0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rom 24 hrs. Data are representative of three independent repeats.</a:t>
            </a:r>
            <a:endParaRPr kumimoji="0" lang="en-AU" altLang="en-US" i="0" strike="noStrike" cap="none" normalizeH="0" baseline="0" dirty="0" smtClean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14744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7</TotalTime>
  <Words>317</Words>
  <Application>Microsoft Office PowerPoint</Application>
  <PresentationFormat>Widescreen</PresentationFormat>
  <Paragraphs>5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University Western Austral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ynat Keam</dc:creator>
  <cp:lastModifiedBy>Synat Keam</cp:lastModifiedBy>
  <cp:revision>19</cp:revision>
  <dcterms:created xsi:type="dcterms:W3CDTF">2021-08-26T06:18:46Z</dcterms:created>
  <dcterms:modified xsi:type="dcterms:W3CDTF">2021-10-15T02:17:01Z</dcterms:modified>
</cp:coreProperties>
</file>